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" userDrawn="1">
          <p15:clr>
            <a:srgbClr val="A4A3A4"/>
          </p15:clr>
        </p15:guide>
        <p15:guide id="2" pos="336" userDrawn="1">
          <p15:clr>
            <a:srgbClr val="A4A3A4"/>
          </p15:clr>
        </p15:guide>
        <p15:guide id="3" pos="3984" userDrawn="1">
          <p15:clr>
            <a:srgbClr val="A4A3A4"/>
          </p15:clr>
        </p15:guide>
        <p15:guide id="4" pos="3672" userDrawn="1">
          <p15:clr>
            <a:srgbClr val="A4A3A4"/>
          </p15:clr>
        </p15:guide>
        <p15:guide id="5" orient="horz" pos="32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3024" y="56"/>
      </p:cViewPr>
      <p:guideLst>
        <p:guide orient="horz" pos="264"/>
        <p:guide pos="336"/>
        <p:guide pos="3984"/>
        <p:guide pos="3672"/>
        <p:guide orient="horz" pos="32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jainir\AppData\Roaming\Microsoft\Excel\distance%20travelled%20(version%202).xlsb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48375953434616"/>
          <c:y val="5.432336692179212E-2"/>
          <c:w val="0.81589622562765474"/>
          <c:h val="0.8003897355121582"/>
        </c:manualLayout>
      </c:layout>
      <c:lineChart>
        <c:grouping val="standard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ombined Distance Data'!$C$10:$C$12</c:f>
                <c:numCache>
                  <c:formatCode>General</c:formatCode>
                  <c:ptCount val="3"/>
                  <c:pt idx="0">
                    <c:v>225.18083579620262</c:v>
                  </c:pt>
                  <c:pt idx="1">
                    <c:v>165.9218775873122</c:v>
                  </c:pt>
                  <c:pt idx="2">
                    <c:v>242.709951290032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mbined Distance Data'!$B$24:$B$26</c:f>
              <c:strCache>
                <c:ptCount val="3"/>
                <c:pt idx="0">
                  <c:v>0-10 min</c:v>
                </c:pt>
                <c:pt idx="1">
                  <c:v>10-20 min</c:v>
                </c:pt>
                <c:pt idx="2">
                  <c:v>20-30 min</c:v>
                </c:pt>
              </c:strCache>
            </c:strRef>
          </c:cat>
          <c:val>
            <c:numRef>
              <c:f>'Combined Distance Data'!$C$24:$C$26</c:f>
              <c:numCache>
                <c:formatCode>General</c:formatCode>
                <c:ptCount val="3"/>
                <c:pt idx="0">
                  <c:v>1797.8074999999999</c:v>
                </c:pt>
                <c:pt idx="1">
                  <c:v>1178.63375</c:v>
                </c:pt>
                <c:pt idx="2">
                  <c:v>1033.3972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2B3-D143-BF4B-52D5D5812CD2}"/>
            </c:ext>
          </c:extLst>
        </c:ser>
        <c:ser>
          <c:idx val="1"/>
          <c:order val="1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square"/>
            <c:size val="7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ombined Distance Data'!$D$10:$D$12</c:f>
                <c:numCache>
                  <c:formatCode>General</c:formatCode>
                  <c:ptCount val="3"/>
                  <c:pt idx="0">
                    <c:v>220.53353568335203</c:v>
                  </c:pt>
                  <c:pt idx="1">
                    <c:v>227.13914749342447</c:v>
                  </c:pt>
                  <c:pt idx="2">
                    <c:v>170.131651169939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mbined Distance Data'!$B$24:$B$26</c:f>
              <c:strCache>
                <c:ptCount val="3"/>
                <c:pt idx="0">
                  <c:v>0-10 min</c:v>
                </c:pt>
                <c:pt idx="1">
                  <c:v>10-20 min</c:v>
                </c:pt>
                <c:pt idx="2">
                  <c:v>20-30 min</c:v>
                </c:pt>
              </c:strCache>
            </c:strRef>
          </c:cat>
          <c:val>
            <c:numRef>
              <c:f>'Combined Distance Data'!$D$24:$D$26</c:f>
              <c:numCache>
                <c:formatCode>General</c:formatCode>
                <c:ptCount val="3"/>
                <c:pt idx="0">
                  <c:v>1659.0056666666669</c:v>
                </c:pt>
                <c:pt idx="1">
                  <c:v>1140.2940000000001</c:v>
                </c:pt>
                <c:pt idx="2">
                  <c:v>923.0573333333333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2B3-D143-BF4B-52D5D5812CD2}"/>
            </c:ext>
          </c:extLst>
        </c:ser>
        <c:ser>
          <c:idx val="2"/>
          <c:order val="2"/>
          <c:spPr>
            <a:ln w="2222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Combined Distance Data'!$E$10:$E$12</c:f>
                <c:numCache>
                  <c:formatCode>General</c:formatCode>
                  <c:ptCount val="3"/>
                  <c:pt idx="0">
                    <c:v>272.78493730817064</c:v>
                  </c:pt>
                  <c:pt idx="1">
                    <c:v>278.91114393939313</c:v>
                  </c:pt>
                  <c:pt idx="2">
                    <c:v>318.333268591267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mbined Distance Data'!$B$24:$B$26</c:f>
              <c:strCache>
                <c:ptCount val="3"/>
                <c:pt idx="0">
                  <c:v>0-10 min</c:v>
                </c:pt>
                <c:pt idx="1">
                  <c:v>10-20 min</c:v>
                </c:pt>
                <c:pt idx="2">
                  <c:v>20-30 min</c:v>
                </c:pt>
              </c:strCache>
            </c:strRef>
          </c:cat>
          <c:val>
            <c:numRef>
              <c:f>'Combined Distance Data'!$E$24:$E$26</c:f>
              <c:numCache>
                <c:formatCode>General</c:formatCode>
                <c:ptCount val="3"/>
                <c:pt idx="0">
                  <c:v>1561.7983333333332</c:v>
                </c:pt>
                <c:pt idx="1">
                  <c:v>1076.6425000000002</c:v>
                </c:pt>
                <c:pt idx="2">
                  <c:v>1086.5883333333334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2B3-D143-BF4B-52D5D5812CD2}"/>
            </c:ext>
          </c:extLst>
        </c:ser>
        <c:ser>
          <c:idx val="3"/>
          <c:order val="3"/>
          <c:spPr>
            <a:ln w="25400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square"/>
            <c:size val="7"/>
            <c:spPr>
              <a:noFill/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ombined Distance Data'!$F$10:$F$12</c:f>
                <c:numCache>
                  <c:formatCode>General</c:formatCode>
                  <c:ptCount val="3"/>
                  <c:pt idx="0">
                    <c:v>231.55277018478535</c:v>
                  </c:pt>
                  <c:pt idx="1">
                    <c:v>229.52017139875286</c:v>
                  </c:pt>
                  <c:pt idx="2">
                    <c:v>260.095213792521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ombined Distance Data'!$B$24:$B$26</c:f>
              <c:strCache>
                <c:ptCount val="3"/>
                <c:pt idx="0">
                  <c:v>0-10 min</c:v>
                </c:pt>
                <c:pt idx="1">
                  <c:v>10-20 min</c:v>
                </c:pt>
                <c:pt idx="2">
                  <c:v>20-30 min</c:v>
                </c:pt>
              </c:strCache>
            </c:strRef>
          </c:cat>
          <c:val>
            <c:numRef>
              <c:f>'Combined Distance Data'!$F$24:$F$26</c:f>
              <c:numCache>
                <c:formatCode>General</c:formatCode>
                <c:ptCount val="3"/>
                <c:pt idx="0">
                  <c:v>1565.886</c:v>
                </c:pt>
                <c:pt idx="1">
                  <c:v>1094.3890000000001</c:v>
                </c:pt>
                <c:pt idx="2">
                  <c:v>870.9937999999999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2B3-D143-BF4B-52D5D5812CD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21146904"/>
        <c:axId val="121424992"/>
      </c:lineChart>
      <c:catAx>
        <c:axId val="121146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1424992"/>
        <c:crosses val="autoZero"/>
        <c:auto val="0"/>
        <c:lblAlgn val="ctr"/>
        <c:lblOffset val="100"/>
        <c:noMultiLvlLbl val="0"/>
      </c:catAx>
      <c:valAx>
        <c:axId val="121424992"/>
        <c:scaling>
          <c:orientation val="minMax"/>
          <c:max val="2100"/>
          <c:min val="7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700">
                    <a:latin typeface="Arial" panose="020B0604020202020204" pitchFamily="34" charset="0"/>
                    <a:cs typeface="Arial" panose="020B0604020202020204" pitchFamily="34" charset="0"/>
                  </a:rPr>
                  <a:t>Distance</a:t>
                </a:r>
                <a:r>
                  <a:rPr lang="en-US" sz="7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Travelled (Inches)</a:t>
                </a:r>
                <a:endParaRPr lang="en-US" sz="7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3.3313676155040397E-3"/>
              <c:y val="0.1974514659440580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1146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5545568225096561"/>
          <c:y val="4.9222267013444114E-2"/>
          <c:w val="0.31427146971848297"/>
          <c:h val="0.393263988220773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bg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0433</cdr:x>
      <cdr:y>0.04732</cdr:y>
    </cdr:from>
    <cdr:to>
      <cdr:x>0.91594</cdr:x>
      <cdr:y>0.13033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1997586" y="91209"/>
          <a:ext cx="600162" cy="159998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700" dirty="0" err="1">
              <a:latin typeface="Arial" panose="020B0604020202020204" pitchFamily="34" charset="0"/>
              <a:cs typeface="Arial" panose="020B0604020202020204" pitchFamily="34" charset="0"/>
            </a:rPr>
            <a:t>Mom</a:t>
          </a:r>
          <a:r>
            <a:rPr lang="en-US" sz="700" baseline="30000" dirty="0" err="1">
              <a:latin typeface="Arial" panose="020B0604020202020204" pitchFamily="34" charset="0"/>
              <a:cs typeface="Arial" panose="020B0604020202020204" pitchFamily="34" charset="0"/>
            </a:rPr>
            <a:t>WT</a:t>
          </a:r>
          <a:r>
            <a:rPr lang="en-US" sz="700" dirty="0" err="1">
              <a:latin typeface="Arial" panose="020B0604020202020204" pitchFamily="34" charset="0"/>
              <a:cs typeface="Arial" panose="020B0604020202020204" pitchFamily="34" charset="0"/>
            </a:rPr>
            <a:t>-Pup</a:t>
          </a:r>
          <a:r>
            <a:rPr lang="en-US" sz="700" baseline="30000" dirty="0" err="1">
              <a:latin typeface="Arial" panose="020B0604020202020204" pitchFamily="34" charset="0"/>
              <a:cs typeface="Arial" panose="020B0604020202020204" pitchFamily="34" charset="0"/>
            </a:rPr>
            <a:t>WT</a:t>
          </a:r>
          <a:endParaRPr lang="en-US" sz="700" baseline="300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0079</cdr:x>
      <cdr:y>0.14435</cdr:y>
    </cdr:from>
    <cdr:to>
      <cdr:x>0.93278</cdr:x>
      <cdr:y>0.22737</cdr:y>
    </cdr:to>
    <cdr:sp macro="" textlink="">
      <cdr:nvSpPr>
        <cdr:cNvPr id="3" name="TextBox 5"/>
        <cdr:cNvSpPr txBox="1"/>
      </cdr:nvSpPr>
      <cdr:spPr>
        <a:xfrm xmlns:a="http://schemas.openxmlformats.org/drawingml/2006/main">
          <a:off x="1987546" y="278230"/>
          <a:ext cx="657963" cy="160018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700">
              <a:latin typeface="Arial" panose="020B0604020202020204" pitchFamily="34" charset="0"/>
              <a:cs typeface="Arial" panose="020B0604020202020204" pitchFamily="34" charset="0"/>
            </a:rPr>
            <a:t>Mom</a:t>
          </a:r>
          <a:r>
            <a:rPr lang="en-US" sz="700" baseline="30000">
              <a:latin typeface="Arial" panose="020B0604020202020204" pitchFamily="34" charset="0"/>
              <a:cs typeface="Arial" panose="020B0604020202020204" pitchFamily="34" charset="0"/>
            </a:rPr>
            <a:t>WT</a:t>
          </a:r>
          <a:r>
            <a:rPr lang="en-US" sz="700">
              <a:latin typeface="Arial" panose="020B0604020202020204" pitchFamily="34" charset="0"/>
              <a:cs typeface="Arial" panose="020B0604020202020204" pitchFamily="34" charset="0"/>
            </a:rPr>
            <a:t>-Pup</a:t>
          </a:r>
          <a:r>
            <a:rPr lang="en-US" sz="700" baseline="30000">
              <a:latin typeface="Arial" panose="020B0604020202020204" pitchFamily="34" charset="0"/>
              <a:cs typeface="Arial" panose="020B0604020202020204" pitchFamily="34" charset="0"/>
            </a:rPr>
            <a:t>m3m4</a:t>
          </a:r>
        </a:p>
      </cdr:txBody>
    </cdr:sp>
  </cdr:relSizeAnchor>
  <cdr:relSizeAnchor xmlns:cdr="http://schemas.openxmlformats.org/drawingml/2006/chartDrawing">
    <cdr:from>
      <cdr:x>0.68813</cdr:x>
      <cdr:y>0.32345</cdr:y>
    </cdr:from>
    <cdr:to>
      <cdr:x>0.94049</cdr:x>
      <cdr:y>0.40646</cdr:y>
    </cdr:to>
    <cdr:sp macro="" textlink="">
      <cdr:nvSpPr>
        <cdr:cNvPr id="4" name="TextBox 6"/>
        <cdr:cNvSpPr txBox="1"/>
      </cdr:nvSpPr>
      <cdr:spPr>
        <a:xfrm xmlns:a="http://schemas.openxmlformats.org/drawingml/2006/main">
          <a:off x="1772508" y="623436"/>
          <a:ext cx="650034" cy="159999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700" dirty="0">
              <a:latin typeface="Arial" panose="020B0604020202020204" pitchFamily="34" charset="0"/>
              <a:cs typeface="Arial" panose="020B0604020202020204" pitchFamily="34" charset="0"/>
            </a:rPr>
            <a:t>Mom</a:t>
          </a:r>
          <a:r>
            <a:rPr lang="en-US" sz="700" baseline="30000" dirty="0">
              <a:latin typeface="Arial" panose="020B0604020202020204" pitchFamily="34" charset="0"/>
              <a:cs typeface="Arial" panose="020B0604020202020204" pitchFamily="34" charset="0"/>
            </a:rPr>
            <a:t>m3m4</a:t>
          </a:r>
          <a:r>
            <a:rPr lang="en-US" sz="700" dirty="0">
              <a:latin typeface="Arial" panose="020B0604020202020204" pitchFamily="34" charset="0"/>
              <a:cs typeface="Arial" panose="020B0604020202020204" pitchFamily="34" charset="0"/>
            </a:rPr>
            <a:t>-Pup</a:t>
          </a:r>
          <a:r>
            <a:rPr lang="en-US" sz="700" baseline="30000" dirty="0">
              <a:latin typeface="Arial" panose="020B0604020202020204" pitchFamily="34" charset="0"/>
              <a:cs typeface="Arial" panose="020B0604020202020204" pitchFamily="34" charset="0"/>
            </a:rPr>
            <a:t>m3m4</a:t>
          </a:r>
        </a:p>
      </cdr:txBody>
    </cdr:sp>
  </cdr:relSizeAnchor>
  <cdr:relSizeAnchor xmlns:cdr="http://schemas.openxmlformats.org/drawingml/2006/chartDrawing">
    <cdr:from>
      <cdr:x>0.70256</cdr:x>
      <cdr:y>0.2333</cdr:y>
    </cdr:from>
    <cdr:to>
      <cdr:x>0.93454</cdr:x>
      <cdr:y>0.31631</cdr:y>
    </cdr:to>
    <cdr:sp macro="" textlink="">
      <cdr:nvSpPr>
        <cdr:cNvPr id="5" name="TextBox 7"/>
        <cdr:cNvSpPr txBox="1"/>
      </cdr:nvSpPr>
      <cdr:spPr>
        <a:xfrm xmlns:a="http://schemas.openxmlformats.org/drawingml/2006/main">
          <a:off x="1992566" y="449678"/>
          <a:ext cx="657935" cy="159998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700">
              <a:latin typeface="Arial" panose="020B0604020202020204" pitchFamily="34" charset="0"/>
              <a:cs typeface="Arial" panose="020B0604020202020204" pitchFamily="34" charset="0"/>
            </a:rPr>
            <a:t>Mom</a:t>
          </a:r>
          <a:r>
            <a:rPr lang="en-US" sz="700" baseline="30000">
              <a:latin typeface="Arial" panose="020B0604020202020204" pitchFamily="34" charset="0"/>
              <a:cs typeface="Arial" panose="020B0604020202020204" pitchFamily="34" charset="0"/>
            </a:rPr>
            <a:t>m3m4</a:t>
          </a:r>
          <a:r>
            <a:rPr lang="en-US" sz="700">
              <a:latin typeface="Arial" panose="020B0604020202020204" pitchFamily="34" charset="0"/>
              <a:cs typeface="Arial" panose="020B0604020202020204" pitchFamily="34" charset="0"/>
            </a:rPr>
            <a:t>-Pup</a:t>
          </a:r>
          <a:r>
            <a:rPr lang="en-US" sz="700" baseline="30000">
              <a:latin typeface="Arial" panose="020B0604020202020204" pitchFamily="34" charset="0"/>
              <a:cs typeface="Arial" panose="020B0604020202020204" pitchFamily="34" charset="0"/>
            </a:rPr>
            <a:t>WT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83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355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827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47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70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595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700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949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258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719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23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F2F01-4441-42A0-85DD-18DC6052AECF}" type="datetimeFigureOut">
              <a:rPr lang="en-US" smtClean="0"/>
              <a:t>4/19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96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oleObject" Target="../embeddings/oleObject1.bin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chart" Target="../charts/chart1.xml"/><Relationship Id="rId4" Type="http://schemas.openxmlformats.org/officeDocument/2006/relationships/image" Target="../media/image1.emf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8904425"/>
              </p:ext>
            </p:extLst>
          </p:nvPr>
        </p:nvGraphicFramePr>
        <p:xfrm>
          <a:off x="3513864" y="2272864"/>
          <a:ext cx="2414587" cy="2232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8" name="Prism 8" r:id="rId3" imgW="2415070" imgH="2231572" progId="Prism8.Document">
                  <p:embed/>
                </p:oleObj>
              </mc:Choice>
              <mc:Fallback>
                <p:oleObj name="Prism 8" r:id="rId3" imgW="2415070" imgH="223157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13864" y="2272864"/>
                        <a:ext cx="2414587" cy="2232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Chart 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43672493"/>
              </p:ext>
            </p:extLst>
          </p:nvPr>
        </p:nvGraphicFramePr>
        <p:xfrm>
          <a:off x="387205" y="2577428"/>
          <a:ext cx="2575819" cy="1927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3" name="TextBox 82"/>
          <p:cNvSpPr txBox="1"/>
          <p:nvPr/>
        </p:nvSpPr>
        <p:spPr>
          <a:xfrm>
            <a:off x="191023" y="31891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60390" y="241180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964570"/>
              </p:ext>
            </p:extLst>
          </p:nvPr>
        </p:nvGraphicFramePr>
        <p:xfrm>
          <a:off x="3289997" y="348223"/>
          <a:ext cx="1992313" cy="1985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9" name="Prism 8" r:id="rId6" imgW="1992631" imgH="1986020" progId="Prism8.Document">
                  <p:embed/>
                </p:oleObj>
              </mc:Choice>
              <mc:Fallback>
                <p:oleObj name="Prism 8" r:id="rId6" imgW="1992631" imgH="198602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89997" y="348223"/>
                        <a:ext cx="1992313" cy="1985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87205" y="4504889"/>
            <a:ext cx="544209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Macrocephaly and ASD like behavior in wild type and female pups derived from mothers of different genotypes. (A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mparison of brain siz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pup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rived from Mo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m3m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om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n=5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ups/group;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0.049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ehavior of female pups derived from Mo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m3m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om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easured b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arble burying (n=6-9; p=0.0036),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Distance travelled over 30 minutes in chamber and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ree chamber sociability test (n=7; p=0.03).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2805769" y="34822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289997" y="241180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1014651"/>
              </p:ext>
            </p:extLst>
          </p:nvPr>
        </p:nvGraphicFramePr>
        <p:xfrm>
          <a:off x="661744" y="385007"/>
          <a:ext cx="1974307" cy="1994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0" name="Prism 9" r:id="rId8" imgW="1718207" imgH="1734707" progId="Prism9.Document">
                  <p:embed/>
                </p:oleObj>
              </mc:Choice>
              <mc:Fallback>
                <p:oleObj name="Prism 9" r:id="rId8" imgW="1718207" imgH="1734707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661744" y="385007"/>
                        <a:ext cx="1974307" cy="1994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0891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9</TotalTime>
  <Words>98</Words>
  <Application>Microsoft Office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8</vt:lpstr>
      <vt:lpstr>GraphPad Prism 9 Project</vt:lpstr>
      <vt:lpstr>PowerPoint Presentation</vt:lpstr>
    </vt:vector>
  </TitlesOfParts>
  <Company>Cleveland Clin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ni, Ritika</dc:creator>
  <cp:lastModifiedBy>Jaini, Ritika</cp:lastModifiedBy>
  <cp:revision>60</cp:revision>
  <cp:lastPrinted>2020-08-18T14:48:40Z</cp:lastPrinted>
  <dcterms:created xsi:type="dcterms:W3CDTF">2020-08-14T21:01:00Z</dcterms:created>
  <dcterms:modified xsi:type="dcterms:W3CDTF">2021-04-19T20:55:59Z</dcterms:modified>
</cp:coreProperties>
</file>